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54" d="100"/>
          <a:sy n="154" d="100"/>
        </p:scale>
        <p:origin x="534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hmad Mohammad Alqudah" userId="cab535fa-7cd2-4138-b8a8-9d630ad5fb17" providerId="ADAL" clId="{FCC7B47F-BFC7-4416-A896-AC5869FDAEDB}"/>
    <pc:docChg chg="modSld">
      <pc:chgData name="Ahmad Mohammad Alqudah" userId="cab535fa-7cd2-4138-b8a8-9d630ad5fb17" providerId="ADAL" clId="{FCC7B47F-BFC7-4416-A896-AC5869FDAEDB}" dt="2021-12-02T08:44:18.609" v="0"/>
      <pc:docMkLst>
        <pc:docMk/>
      </pc:docMkLst>
      <pc:sldChg chg="modSp mod">
        <pc:chgData name="Ahmad Mohammad Alqudah" userId="cab535fa-7cd2-4138-b8a8-9d630ad5fb17" providerId="ADAL" clId="{FCC7B47F-BFC7-4416-A896-AC5869FDAEDB}" dt="2021-12-02T08:44:18.609" v="0"/>
        <pc:sldMkLst>
          <pc:docMk/>
          <pc:sldMk cId="480980905" sldId="256"/>
        </pc:sldMkLst>
        <pc:spChg chg="mod">
          <ac:chgData name="Ahmad Mohammad Alqudah" userId="cab535fa-7cd2-4138-b8a8-9d630ad5fb17" providerId="ADAL" clId="{FCC7B47F-BFC7-4416-A896-AC5869FDAEDB}" dt="2021-12-02T08:44:18.609" v="0"/>
          <ac:spMkLst>
            <pc:docMk/>
            <pc:sldMk cId="480980905" sldId="256"/>
            <ac:spMk id="6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DC89F-D517-42D7-BF92-E1CE86EE7F2A}" type="datetimeFigureOut">
              <a:rPr lang="en-US" smtClean="0"/>
              <a:t>12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92D2A-9E9D-4596-838D-54A7EF9BE0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77862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DC89F-D517-42D7-BF92-E1CE86EE7F2A}" type="datetimeFigureOut">
              <a:rPr lang="en-US" smtClean="0"/>
              <a:t>12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92D2A-9E9D-4596-838D-54A7EF9BE0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12652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DC89F-D517-42D7-BF92-E1CE86EE7F2A}" type="datetimeFigureOut">
              <a:rPr lang="en-US" smtClean="0"/>
              <a:t>12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92D2A-9E9D-4596-838D-54A7EF9BE0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43682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DC89F-D517-42D7-BF92-E1CE86EE7F2A}" type="datetimeFigureOut">
              <a:rPr lang="en-US" smtClean="0"/>
              <a:t>12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92D2A-9E9D-4596-838D-54A7EF9BE0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60448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DC89F-D517-42D7-BF92-E1CE86EE7F2A}" type="datetimeFigureOut">
              <a:rPr lang="en-US" smtClean="0"/>
              <a:t>12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92D2A-9E9D-4596-838D-54A7EF9BE0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4733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DC89F-D517-42D7-BF92-E1CE86EE7F2A}" type="datetimeFigureOut">
              <a:rPr lang="en-US" smtClean="0"/>
              <a:t>12/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92D2A-9E9D-4596-838D-54A7EF9BE0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05782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DC89F-D517-42D7-BF92-E1CE86EE7F2A}" type="datetimeFigureOut">
              <a:rPr lang="en-US" smtClean="0"/>
              <a:t>12/2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92D2A-9E9D-4596-838D-54A7EF9BE0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54869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DC89F-D517-42D7-BF92-E1CE86EE7F2A}" type="datetimeFigureOut">
              <a:rPr lang="en-US" smtClean="0"/>
              <a:t>12/2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92D2A-9E9D-4596-838D-54A7EF9BE0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5906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DC89F-D517-42D7-BF92-E1CE86EE7F2A}" type="datetimeFigureOut">
              <a:rPr lang="en-US" smtClean="0"/>
              <a:t>12/2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92D2A-9E9D-4596-838D-54A7EF9BE0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91320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DC89F-D517-42D7-BF92-E1CE86EE7F2A}" type="datetimeFigureOut">
              <a:rPr lang="en-US" smtClean="0"/>
              <a:t>12/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92D2A-9E9D-4596-838D-54A7EF9BE0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94128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DC89F-D517-42D7-BF92-E1CE86EE7F2A}" type="datetimeFigureOut">
              <a:rPr lang="en-US" smtClean="0"/>
              <a:t>12/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92D2A-9E9D-4596-838D-54A7EF9BE0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62778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BDC89F-D517-42D7-BF92-E1CE86EE7F2A}" type="datetimeFigureOut">
              <a:rPr lang="en-US" smtClean="0"/>
              <a:t>12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D92D2A-9E9D-4596-838D-54A7EF9BE0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51761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63" t="-494" r="13091" b="4898"/>
          <a:stretch>
            <a:fillRect/>
          </a:stretch>
        </p:blipFill>
        <p:spPr bwMode="auto">
          <a:xfrm>
            <a:off x="432620" y="277924"/>
            <a:ext cx="4306527" cy="38650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Rectangle 5"/>
          <p:cNvSpPr/>
          <p:nvPr/>
        </p:nvSpPr>
        <p:spPr>
          <a:xfrm>
            <a:off x="688258" y="4426565"/>
            <a:ext cx="10756490" cy="246221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indent="-152400"/>
            <a:r>
              <a:rPr lang="en-US" sz="20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. S1: </a:t>
            </a:r>
            <a:r>
              <a:rPr lang="en-US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Unweighted Pair Group Method with Arithmetic average (UPGMA)  dendrogram of the genetic dissimilarity of the </a:t>
            </a:r>
            <a:r>
              <a:rPr lang="en-US" sz="2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omato</a:t>
            </a:r>
            <a:r>
              <a:rPr lang="en-US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ccessions based on Euclidean distance coefficient using proline content at 4 </a:t>
            </a:r>
            <a:r>
              <a:rPr lang="en-US" sz="2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dS</a:t>
            </a:r>
            <a:r>
              <a:rPr lang="en-US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m</a:t>
            </a:r>
            <a:r>
              <a:rPr lang="he-IL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ֿ</a:t>
            </a:r>
            <a:r>
              <a:rPr lang="en-US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¹ salinity level.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1. Jo111A, 2.  Jo 111B, 3.  Jo 960, 5.  Jo 952, 6. Jo 956, 8.  Jo 972, 9.  Jo 973 11. Jo 967B, 12. 9 Jo 71A, 13. Jo 971B, 14.  Jo 961, 15.  Jo 979, 17.  Jo 989,  18.  Jo 968, 19.  Jo 958, 20. Jo 974B, 21. Jo 974A, 22.  Jo 994A, 23.  Jo 978, 24.  Jo 970, 25.  Jo 969, 26.  Jo 981, 27.  Jo 991A, 28.  Jo 991B, 29.  Jo 964,  30.  Jo 959, 31.  Jo 976, 32.  Jo 975, 33.  Jo 963, 34.  Jo 985, 36.  Jo 987, 37. Jo 957, 38. Jo 955,  39. Jo 980A</a:t>
            </a:r>
            <a:endParaRPr lang="en-US" sz="2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R="190500" algn="justLow"/>
            <a:r>
              <a:rPr lang="ar-SA" sz="2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  <a:endParaRPr lang="en-US" sz="2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Low"/>
            <a:r>
              <a:rPr lang="en-US" sz="2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</a:p>
        </p:txBody>
      </p:sp>
    </p:spTree>
    <p:extLst>
      <p:ext uri="{BB962C8B-B14F-4D97-AF65-F5344CB8AC3E}">
        <p14:creationId xmlns:p14="http://schemas.microsoft.com/office/powerpoint/2010/main" val="4809809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64" r="9409" b="3067"/>
          <a:stretch>
            <a:fillRect/>
          </a:stretch>
        </p:blipFill>
        <p:spPr bwMode="auto">
          <a:xfrm>
            <a:off x="1199536" y="433323"/>
            <a:ext cx="5663380" cy="346821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Rectangle 4"/>
          <p:cNvSpPr/>
          <p:nvPr/>
        </p:nvSpPr>
        <p:spPr>
          <a:xfrm>
            <a:off x="993058" y="4790182"/>
            <a:ext cx="10746658" cy="12618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indent="-152400"/>
            <a:r>
              <a:rPr lang="en-US" sz="20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Fig. S2:</a:t>
            </a:r>
            <a:r>
              <a:rPr lang="en-US" sz="2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UPGMA </a:t>
            </a:r>
            <a:r>
              <a:rPr lang="en-US" sz="2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dendrogram</a:t>
            </a:r>
            <a:r>
              <a:rPr lang="en-US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of the genetic dissimilarity of the </a:t>
            </a:r>
            <a:r>
              <a:rPr lang="en-US" sz="2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omato</a:t>
            </a:r>
            <a:r>
              <a:rPr lang="en-US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ccessions based on Euclidean distance coefficient using </a:t>
            </a:r>
            <a:r>
              <a:rPr lang="en-US" sz="2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roline</a:t>
            </a:r>
            <a:r>
              <a:rPr lang="en-US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content at 6 </a:t>
            </a:r>
            <a:r>
              <a:rPr lang="en-US" sz="2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dS</a:t>
            </a:r>
            <a:r>
              <a:rPr lang="en-US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m</a:t>
            </a:r>
            <a:r>
              <a:rPr lang="he-IL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ֿ</a:t>
            </a:r>
            <a:r>
              <a:rPr lang="en-US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¹ salinity level.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21. Jo 974A, 23.  Jo 978, 24.  Jo 970, 25,  Jo 969, 29.  Jo 964,  30.  Jo 959, 31.  Jo 976, 32.  Jo 975,  33.  Jo 963, 34.  Jo 985,  36.  Jo 987,  38. Jo 955, 39. Jo 980A, 37. Jo 957</a:t>
            </a:r>
            <a:endParaRPr lang="en-US" sz="2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119467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66" r="8670" b="6894"/>
          <a:stretch>
            <a:fillRect/>
          </a:stretch>
        </p:blipFill>
        <p:spPr bwMode="auto">
          <a:xfrm>
            <a:off x="750416" y="201409"/>
            <a:ext cx="3644604" cy="43017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Rectangle 2"/>
          <p:cNvSpPr/>
          <p:nvPr/>
        </p:nvSpPr>
        <p:spPr>
          <a:xfrm>
            <a:off x="750416" y="4503175"/>
            <a:ext cx="10481187" cy="1815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indent="-152400"/>
            <a:r>
              <a:rPr lang="en-US" sz="20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Fig. S3:</a:t>
            </a:r>
            <a:r>
              <a:rPr lang="en-US" sz="2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UPGMA </a:t>
            </a:r>
            <a:r>
              <a:rPr lang="en-US" sz="2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dendrogram</a:t>
            </a:r>
            <a:r>
              <a:rPr lang="en-US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of the genetic dissimilarity of the </a:t>
            </a:r>
            <a:r>
              <a:rPr lang="en-US" sz="2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omato</a:t>
            </a:r>
            <a:r>
              <a:rPr lang="en-US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ccessions based on Euclidean distance coefficient using </a:t>
            </a:r>
            <a:r>
              <a:rPr lang="en-US" sz="2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hoot mineral content</a:t>
            </a:r>
            <a:r>
              <a:rPr lang="en-US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t 4 </a:t>
            </a:r>
            <a:r>
              <a:rPr lang="en-US" sz="2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dS</a:t>
            </a:r>
            <a:r>
              <a:rPr lang="en-US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m</a:t>
            </a:r>
            <a:r>
              <a:rPr lang="he-IL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ֿ</a:t>
            </a:r>
            <a:r>
              <a:rPr lang="en-US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¹ salinity level. </a:t>
            </a:r>
            <a:endParaRPr lang="en-US" sz="2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R="0" lvl="0" algn="justLow">
              <a:spcBef>
                <a:spcPts val="0"/>
              </a:spcBef>
              <a:spcAft>
                <a:spcPts val="0"/>
              </a:spcAft>
              <a:tabLst>
                <a:tab pos="152400" algn="l"/>
              </a:tabLst>
            </a:pP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Jo111A, 2.  Jo 111B, 3.  Jo 960, 5.  Jo 952, 6. Jo 956, 8.  Jo 972, 9.  Jo 973 11. Jo 967B, 12. 9 Jo 71A, 13. Jo 971B, 14.  Jo 961, 15.  Jo 979, 17.  Jo 989,  18.  Jo 968, 19.  Jo 958, 20. Jo 974B, 21. Jo 974A, 22.  Jo 994A, 23.  Jo 978, 24.  Jo 970, 25.  Jo 969, 26.  Jo 981, 27.  Jo 991A, 28.  Jo 991B, 29.  Jo 964,  30.  Jo 959, 31.  Jo 976, 32.  Jo 975, 33.  Jo 963, 34.  Jo 985, 36.  Jo 987, 37. Jo 957, 38. Jo 955,  39. Jo 980A</a:t>
            </a:r>
            <a:endParaRPr lang="en-US" sz="2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3288813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319" b="4897"/>
          <a:stretch>
            <a:fillRect/>
          </a:stretch>
        </p:blipFill>
        <p:spPr bwMode="auto">
          <a:xfrm>
            <a:off x="811008" y="550606"/>
            <a:ext cx="5551487" cy="3397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Rectangle 2"/>
          <p:cNvSpPr/>
          <p:nvPr/>
        </p:nvSpPr>
        <p:spPr>
          <a:xfrm>
            <a:off x="811008" y="4514032"/>
            <a:ext cx="10732063" cy="153888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indent="-152400"/>
            <a:r>
              <a:rPr lang="en-US" sz="20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Fig. S4:</a:t>
            </a:r>
            <a:r>
              <a:rPr lang="en-US" sz="2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UPGMA </a:t>
            </a:r>
            <a:r>
              <a:rPr lang="en-US" sz="2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dendrogram</a:t>
            </a:r>
            <a:r>
              <a:rPr lang="en-US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of the genetic dissimilarity of the </a:t>
            </a:r>
            <a:r>
              <a:rPr lang="en-US" sz="2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omato</a:t>
            </a:r>
            <a:r>
              <a:rPr lang="en-US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ccessions based on Euclidean distance coefficient using </a:t>
            </a:r>
            <a:r>
              <a:rPr lang="en-US" sz="2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hoot </a:t>
            </a:r>
            <a:r>
              <a:rPr lang="en-US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ineral content at 6 </a:t>
            </a:r>
            <a:r>
              <a:rPr lang="en-US" sz="2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dS</a:t>
            </a:r>
            <a:r>
              <a:rPr lang="en-US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m</a:t>
            </a:r>
            <a:r>
              <a:rPr lang="he-IL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ֿ</a:t>
            </a:r>
            <a:r>
              <a:rPr lang="en-US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¹ salinity level. </a:t>
            </a:r>
            <a:endParaRPr lang="en-US" sz="2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Low"/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21. Jo 974A, 23.  Jo 978, 24.  Jo 970, 25,  Jo 969, 29.  Jo 964,  30.  Jo 959, 31.  Jo 976, 32.  Jo 975,  33.  Jo 963, 34.  Jo 985,  36.  Jo 987,  38. Jo 955, 39. Jo 980A, 37. Jo 957</a:t>
            </a:r>
            <a:endParaRPr lang="en-US" sz="2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Low"/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  <a:endParaRPr lang="en-US" sz="2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8250215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83" r="6168"/>
          <a:stretch>
            <a:fillRect/>
          </a:stretch>
        </p:blipFill>
        <p:spPr bwMode="auto">
          <a:xfrm>
            <a:off x="206477" y="176980"/>
            <a:ext cx="4424679" cy="43224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Rectangle 2"/>
          <p:cNvSpPr/>
          <p:nvPr/>
        </p:nvSpPr>
        <p:spPr>
          <a:xfrm>
            <a:off x="386633" y="4617401"/>
            <a:ext cx="10320696" cy="1815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Low"/>
            <a:r>
              <a:rPr lang="en-US" sz="20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Fig. S5:</a:t>
            </a:r>
            <a:r>
              <a:rPr lang="en-US" sz="2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2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UPGMA </a:t>
            </a:r>
            <a:r>
              <a:rPr lang="en-US" sz="20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dendrogram</a:t>
            </a:r>
            <a:r>
              <a:rPr lang="en-US" sz="2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of the genetic dissimilarity of the </a:t>
            </a:r>
            <a:r>
              <a:rPr lang="en-US" sz="2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tomato</a:t>
            </a:r>
            <a:r>
              <a:rPr lang="en-US" sz="2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accessions based on Euclidean distance coefficient using </a:t>
            </a:r>
            <a:r>
              <a:rPr lang="en-US" sz="2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root mineral content</a:t>
            </a:r>
            <a:r>
              <a:rPr lang="en-US" sz="2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at 4 </a:t>
            </a:r>
            <a:r>
              <a:rPr lang="en-US" sz="20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dS</a:t>
            </a:r>
            <a:r>
              <a:rPr lang="en-US" sz="2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m</a:t>
            </a:r>
            <a:r>
              <a:rPr lang="he-IL" sz="2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ֿ</a:t>
            </a:r>
            <a:r>
              <a:rPr lang="en-US" sz="2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¹ salinity level</a:t>
            </a:r>
            <a:endParaRPr lang="en-US" sz="20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R="0" lvl="0" algn="justLow">
              <a:spcBef>
                <a:spcPts val="0"/>
              </a:spcBef>
              <a:spcAft>
                <a:spcPts val="0"/>
              </a:spcAft>
              <a:tabLst>
                <a:tab pos="152400" algn="l"/>
              </a:tabLst>
            </a:pP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Jo111A, 2.  Jo 111B, 3.  Jo 960, 5.  Jo 952, 6. Jo 956, 8.  Jo 972, 9.  Jo 973 11. Jo 967B, 12. 9 Jo 71A, 13. Jo 971B, 14.  Jo 961, 15.  Jo 979, 17.  Jo 989,  18.  Jo 968, 19.  Jo 958, 20. Jo 974B, 21. Jo 974A, 22.  Jo 994A, 23.  Jo 978, 24.  Jo 970, 25.  Jo 969, 26.  Jo 981, 27.  Jo 991A, 28.  Jo 991B, 29.  Jo 964,  30.  Jo 959, 31.  Jo 976, 32.  Jo 975, 33.  Jo 963, 34.  Jo 985, 36.  Jo 987, 37. Jo 957, 38. Jo 955,  39. Jo 980A</a:t>
            </a:r>
            <a:endParaRPr lang="en-US" sz="2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744117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589934" y="5075318"/>
            <a:ext cx="9566787" cy="12618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indent="-152400"/>
            <a:r>
              <a:rPr lang="en-US" sz="20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Fig. S6:</a:t>
            </a:r>
            <a:r>
              <a:rPr lang="en-US" sz="2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UPGMA </a:t>
            </a:r>
            <a:r>
              <a:rPr lang="en-US" sz="2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dendrogram</a:t>
            </a:r>
            <a:r>
              <a:rPr lang="en-US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of the genetic dissimilarity of the </a:t>
            </a:r>
            <a:r>
              <a:rPr lang="en-US" sz="2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omato</a:t>
            </a:r>
            <a:r>
              <a:rPr lang="en-US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ccessions based on Euclidean distance coefficient using </a:t>
            </a:r>
            <a:r>
              <a:rPr lang="en-US" sz="2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root </a:t>
            </a:r>
            <a:r>
              <a:rPr lang="en-US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ineral content at 6 </a:t>
            </a:r>
            <a:r>
              <a:rPr lang="en-US" sz="2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dS</a:t>
            </a:r>
            <a:r>
              <a:rPr lang="en-US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m</a:t>
            </a:r>
            <a:r>
              <a:rPr lang="he-IL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ֿ</a:t>
            </a:r>
            <a:r>
              <a:rPr lang="en-US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¹ salinity level. </a:t>
            </a:r>
            <a:endParaRPr lang="en-US" sz="2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Low"/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21. Jo 974A, 23.  Jo 978, 24.  Jo 970, 25,  Jo 969, 29.  Jo 964,  30.  Jo 959, 31.  Jo 976, 32.  Jo 975,  33.  Jo 963, 34.  Jo 985,  36.  Jo 987,  38. Jo 955, 39. Jo 980A, 37. Jo 957</a:t>
            </a:r>
            <a:endParaRPr lang="en-US" sz="2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3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413"/>
          <a:stretch>
            <a:fillRect/>
          </a:stretch>
        </p:blipFill>
        <p:spPr bwMode="auto">
          <a:xfrm>
            <a:off x="711098" y="684775"/>
            <a:ext cx="5640541" cy="36594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3089886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908</Words>
  <Application>Microsoft Office PowerPoint</Application>
  <PresentationFormat>Widescreen</PresentationFormat>
  <Paragraphs>13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mar</dc:creator>
  <cp:lastModifiedBy>Ahmad Mohammad Alqudah</cp:lastModifiedBy>
  <cp:revision>7</cp:revision>
  <dcterms:created xsi:type="dcterms:W3CDTF">2021-09-16T12:09:19Z</dcterms:created>
  <dcterms:modified xsi:type="dcterms:W3CDTF">2021-12-02T08:44:47Z</dcterms:modified>
</cp:coreProperties>
</file>